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  <p:sldId id="273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561" autoAdjust="0"/>
    <p:restoredTop sz="96429" autoAdjust="0"/>
  </p:normalViewPr>
  <p:slideViewPr>
    <p:cSldViewPr snapToGrid="0">
      <p:cViewPr varScale="1">
        <p:scale>
          <a:sx n="109" d="100"/>
          <a:sy n="109" d="100"/>
        </p:scale>
        <p:origin x="90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F785F-9322-4B08-ADC7-7C0DBACE029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13A2-F291-4D74-BD8B-7C70315BA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71377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F785F-9322-4B08-ADC7-7C0DBACE029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13A2-F291-4D74-BD8B-7C70315BA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0006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F785F-9322-4B08-ADC7-7C0DBACE029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13A2-F291-4D74-BD8B-7C70315BA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35983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F785F-9322-4B08-ADC7-7C0DBACE029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13A2-F291-4D74-BD8B-7C70315BA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5245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F785F-9322-4B08-ADC7-7C0DBACE029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13A2-F291-4D74-BD8B-7C70315BA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0335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F785F-9322-4B08-ADC7-7C0DBACE029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13A2-F291-4D74-BD8B-7C70315BA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5481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F785F-9322-4B08-ADC7-7C0DBACE029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13A2-F291-4D74-BD8B-7C70315BA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535950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F785F-9322-4B08-ADC7-7C0DBACE029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13A2-F291-4D74-BD8B-7C70315BA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40146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F785F-9322-4B08-ADC7-7C0DBACE029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13A2-F291-4D74-BD8B-7C70315BA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31401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F785F-9322-4B08-ADC7-7C0DBACE029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13A2-F291-4D74-BD8B-7C70315BA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9952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F785F-9322-4B08-ADC7-7C0DBACE029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13A2-F291-4D74-BD8B-7C70315BA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84799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CF785F-9322-4B08-ADC7-7C0DBACE029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E513A2-F291-4D74-BD8B-7C70315BA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297558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/>
          <p:cNvSpPr/>
          <p:nvPr/>
        </p:nvSpPr>
        <p:spPr>
          <a:xfrm>
            <a:off x="2898530" y="262076"/>
            <a:ext cx="6096000" cy="3693319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GB" b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GB" b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terial</a:t>
            </a:r>
          </a:p>
          <a:p>
            <a:pPr algn="ctr">
              <a:lnSpc>
                <a:spcPct val="150000"/>
              </a:lnSpc>
            </a:pPr>
            <a:r>
              <a:rPr lang="en-GB" b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o</a:t>
            </a:r>
            <a:endParaRPr lang="de-DE" b="1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endParaRPr lang="en-GB" sz="1200" b="1" smtClean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twork </a:t>
            </a:r>
            <a:r>
              <a:rPr lang="en-GB" sz="1200" b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ta-analysis of transcriptome expression changes in different manifestations of dengue virus infection</a:t>
            </a:r>
            <a:endParaRPr lang="de-DE" sz="120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de-DE" sz="120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2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ristine Winter</a:t>
            </a:r>
            <a:r>
              <a:rPr lang="de-DE" sz="1200" baseline="300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de-DE" sz="12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ntónio A. R. Cama</a:t>
            </a:r>
            <a:r>
              <a:rPr lang="de-DE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ã</a:t>
            </a:r>
            <a:r>
              <a:rPr lang="de-DE" sz="12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de-DE" sz="1200" baseline="300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de-DE" sz="12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Imke Steffen</a:t>
            </a:r>
            <a:r>
              <a:rPr lang="de-DE" sz="1200" baseline="300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de-DE" sz="12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Klaus Jung</a:t>
            </a:r>
            <a:r>
              <a:rPr lang="de-DE" sz="1200" baseline="300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*</a:t>
            </a:r>
            <a:endParaRPr lang="de-DE" sz="120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2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) Institute for Animal Breeding and Genetics, University of Veterinary Medicine Hannover, Hannover, Germany</a:t>
            </a:r>
            <a:endParaRPr lang="de-DE" sz="120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) Department of Biochemistry and Research Center for Emerging Infections and Zoonoses, University of Veterinary Medicine Hannover, Hannover, </a:t>
            </a:r>
            <a:r>
              <a:rPr lang="en-GB" sz="120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rmany</a:t>
            </a:r>
            <a:endParaRPr lang="en-GB" sz="120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1573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hteck 2"/>
          <p:cNvSpPr/>
          <p:nvPr/>
        </p:nvSpPr>
        <p:spPr>
          <a:xfrm>
            <a:off x="2951285" y="4790362"/>
            <a:ext cx="6096000" cy="92333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smtClean="0"/>
              <a:t>Figure S: </a:t>
            </a:r>
            <a:r>
              <a:rPr lang="en-GB" sz="1200" smtClean="0"/>
              <a:t>Overlap of top genes reported in the individual studies and by the network meta-analysis. A) Presentation of pairwise overlaps between the individual studies and the network meta-analysis as gene lists. B) Overlaps between all studies illustrated by a Venn diagram.</a:t>
            </a:r>
            <a:endParaRPr lang="en-GB" sz="120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5" name="Gruppieren 4"/>
          <p:cNvGrpSpPr/>
          <p:nvPr/>
        </p:nvGrpSpPr>
        <p:grpSpPr>
          <a:xfrm>
            <a:off x="627917" y="676608"/>
            <a:ext cx="10320704" cy="3818726"/>
            <a:chOff x="744415" y="632647"/>
            <a:chExt cx="10320704" cy="3818726"/>
          </a:xfrm>
        </p:grpSpPr>
        <p:sp>
          <p:nvSpPr>
            <p:cNvPr id="2" name="Rechteck 1"/>
            <p:cNvSpPr/>
            <p:nvPr/>
          </p:nvSpPr>
          <p:spPr>
            <a:xfrm>
              <a:off x="744415" y="1096174"/>
              <a:ext cx="6096000" cy="3016210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&gt; </a:t>
              </a:r>
              <a:r>
                <a:rPr lang="de-DE" sz="100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intersect(NetworkMetaAnalysis, </a:t>
              </a:r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Long2009)</a:t>
              </a:r>
            </a:p>
            <a:p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 [1] "AURKB"   "BFSP2"   "BIRC5"   "BUB1"    "C1QB"    "CCNA2"   "CCNB2"  </a:t>
              </a:r>
            </a:p>
            <a:p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 [8] "CD38"    "CDC20"   "CDCA2"   "CDCA3"   "CDCA5"   "CDCA8"   "CDT1"   </a:t>
              </a:r>
            </a:p>
            <a:p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[15] "IFI27"   "KCTD14"  "KIF2C"   "MKI67"   "MYBL2"   "NUSAP1"  "PHGDH"  </a:t>
              </a:r>
            </a:p>
            <a:p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[22] "PI3"     "SESN3"   "SLCO4A1" "TK1"     "TPX2"    "TRIP13"  "TROAP"  </a:t>
              </a:r>
            </a:p>
            <a:p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[29] "UCHL1"   "ZFP36L2"</a:t>
              </a:r>
            </a:p>
            <a:p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&gt; </a:t>
              </a:r>
              <a:r>
                <a:rPr lang="de-DE" sz="100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intersect(</a:t>
              </a:r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NetworkMetaAnalysis</a:t>
              </a:r>
              <a:r>
                <a:rPr lang="de-DE" sz="100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, </a:t>
              </a:r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Loke2010)</a:t>
              </a:r>
            </a:p>
            <a:p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 [1] "ACADM"   "BUB1"    "DNAJC15" "IMPA1"   "MRPS18C" "OLIG1"   "PDCD10" </a:t>
              </a:r>
            </a:p>
            <a:p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 [8] "PSMA3"   "PSMA4"   "RPL26"   "SAR1B"   "STT3B"   "TIMM8B"  "USO1"   </a:t>
              </a:r>
            </a:p>
            <a:p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&gt; </a:t>
              </a:r>
              <a:r>
                <a:rPr lang="de-DE" sz="100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intersect(</a:t>
              </a:r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NetworkMetaAnalysis</a:t>
              </a:r>
              <a:r>
                <a:rPr lang="de-DE" sz="100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, </a:t>
              </a:r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Popper2012)</a:t>
              </a:r>
            </a:p>
            <a:p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 [1] "BCL2L12" "CDC25A"  "CEP55"   "GLUL"    "HBEGF"   "IRF4"    "IRS2"   </a:t>
              </a:r>
            </a:p>
            <a:p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 [8] "ITM2B"   "MGC5618" "MYBL2"   "NUSAP1"  "OLIG1"   "PDIA5"   "POLE2"  </a:t>
              </a:r>
            </a:p>
            <a:p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[15] "RRM2"    "TCF19"   "THBS1"   "TRIP13"  "TYMS"   </a:t>
              </a:r>
            </a:p>
            <a:p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&gt; </a:t>
              </a:r>
              <a:r>
                <a:rPr lang="de-DE" sz="100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intersect(</a:t>
              </a:r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NetworkMetaAnalysis</a:t>
              </a:r>
              <a:r>
                <a:rPr lang="de-DE" sz="100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, </a:t>
              </a:r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Sun2013)</a:t>
              </a:r>
            </a:p>
            <a:p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 [1] "BIRC5"     "BUB1"      "CACNA2D3"  "CCNA2"     "CCNB2"     "CD1C"     </a:t>
              </a:r>
            </a:p>
            <a:p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 [7] "CD38"      "CDC20"     "CDK1"      "CDKN3"     "ENPP5"     "FABP5"    </a:t>
              </a:r>
            </a:p>
            <a:p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[13] "FEN1"      "HMMR"      "IFI27"     "ISG15"     "LOC286087" "MCM6"     </a:t>
              </a:r>
            </a:p>
            <a:p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[19] "NCAPG"     "NUSAP1"    "PBK"       "PLA2G7"    "PPM1L"     "RRM2"     </a:t>
              </a:r>
            </a:p>
            <a:p>
              <a:r>
                <a:rPr lang="de-DE" sz="1000">
                  <a:latin typeface="Courier New" panose="02070309020205020404" pitchFamily="49" charset="0"/>
                  <a:cs typeface="Courier New" panose="02070309020205020404" pitchFamily="49" charset="0"/>
                </a:rPr>
                <a:t>[25] "RTN1"      "SOCS2"     "TPX2"      "TYMS"      "USP18"     "ZAK"</a:t>
              </a:r>
            </a:p>
          </p:txBody>
        </p:sp>
        <p:pic>
          <p:nvPicPr>
            <p:cNvPr id="8" name="Grafik 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501631" y="893785"/>
              <a:ext cx="3563488" cy="3557588"/>
            </a:xfrm>
            <a:prstGeom prst="rect">
              <a:avLst/>
            </a:prstGeom>
          </p:spPr>
        </p:pic>
        <p:sp>
          <p:nvSpPr>
            <p:cNvPr id="9" name="Rechteck 8"/>
            <p:cNvSpPr/>
            <p:nvPr/>
          </p:nvSpPr>
          <p:spPr>
            <a:xfrm>
              <a:off x="744415" y="632647"/>
              <a:ext cx="328247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lnSpc>
                  <a:spcPct val="150000"/>
                </a:lnSpc>
                <a:spcAft>
                  <a:spcPts val="0"/>
                </a:spcAft>
              </a:pPr>
              <a:r>
                <a:rPr lang="en-GB" sz="1200" b="1" smtClean="0"/>
                <a:t>A)</a:t>
              </a:r>
              <a:endParaRPr lang="en-GB" sz="12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Rechteck 9"/>
            <p:cNvSpPr/>
            <p:nvPr/>
          </p:nvSpPr>
          <p:spPr>
            <a:xfrm>
              <a:off x="7675684" y="638409"/>
              <a:ext cx="328247" cy="34073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lnSpc>
                  <a:spcPct val="150000"/>
                </a:lnSpc>
                <a:spcAft>
                  <a:spcPts val="0"/>
                </a:spcAft>
              </a:pPr>
              <a:r>
                <a:rPr lang="en-GB" sz="1200" b="1"/>
                <a:t>B</a:t>
              </a:r>
              <a:r>
                <a:rPr lang="en-GB" sz="1200" b="1" smtClean="0"/>
                <a:t>)</a:t>
              </a:r>
              <a:endParaRPr lang="en-GB" sz="12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125724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9</Words>
  <Application>Microsoft Office PowerPoint</Application>
  <PresentationFormat>Breitbild</PresentationFormat>
  <Paragraphs>31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Courier New</vt:lpstr>
      <vt:lpstr>Times New Roman</vt:lpstr>
      <vt:lpstr>Office</vt:lpstr>
      <vt:lpstr>PowerPoint-Präsentation</vt:lpstr>
      <vt:lpstr>PowerPoint-Präsentation</vt:lpstr>
    </vt:vector>
  </TitlesOfParts>
  <Company>TiH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ung, Klaus</dc:creator>
  <cp:lastModifiedBy>Jung, Klaus</cp:lastModifiedBy>
  <cp:revision>36</cp:revision>
  <dcterms:created xsi:type="dcterms:W3CDTF">2021-05-27T08:53:18Z</dcterms:created>
  <dcterms:modified xsi:type="dcterms:W3CDTF">2021-12-15T10:22:11Z</dcterms:modified>
</cp:coreProperties>
</file>